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2"/>
    <p:restoredTop sz="94712"/>
  </p:normalViewPr>
  <p:slideViewPr>
    <p:cSldViewPr snapToGrid="0" snapToObjects="1" showGuides="1">
      <p:cViewPr varScale="1">
        <p:scale>
          <a:sx n="96" d="100"/>
          <a:sy n="96" d="100"/>
        </p:scale>
        <p:origin x="168" y="5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azu\Desktop\ASTS-Surrogacy-Funnel-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Kazu\Desktop\ASTS-Surrogacy-Funnel-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27133862726329"/>
          <c:y val="3.9993013016988224E-2"/>
          <c:w val="0.81376460530065542"/>
          <c:h val="0.86199044984355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53975">
                <a:solidFill>
                  <a:schemeClr val="tx1"/>
                </a:solidFill>
              </a:ln>
              <a:effectLst/>
            </c:spPr>
          </c:marker>
          <c:xVal>
            <c:numRef>
              <c:f>Sheet1!$B$2:$B$16</c:f>
              <c:numCache>
                <c:formatCode>General</c:formatCode>
                <c:ptCount val="15"/>
                <c:pt idx="0">
                  <c:v>0.10979999999999999</c:v>
                </c:pt>
                <c:pt idx="1">
                  <c:v>2.76E-2</c:v>
                </c:pt>
                <c:pt idx="2">
                  <c:v>-0.1404</c:v>
                </c:pt>
                <c:pt idx="3">
                  <c:v>0.48299999999999998</c:v>
                </c:pt>
                <c:pt idx="4">
                  <c:v>0.29189999999999999</c:v>
                </c:pt>
                <c:pt idx="5">
                  <c:v>0.15190000000000001</c:v>
                </c:pt>
                <c:pt idx="6">
                  <c:v>-3.7699999999999997E-2</c:v>
                </c:pt>
                <c:pt idx="7">
                  <c:v>-0.1358</c:v>
                </c:pt>
                <c:pt idx="8">
                  <c:v>-6.2899999999999998E-2</c:v>
                </c:pt>
                <c:pt idx="9">
                  <c:v>3.0000000000000001E-3</c:v>
                </c:pt>
                <c:pt idx="10">
                  <c:v>-2.3300000000000001E-2</c:v>
                </c:pt>
                <c:pt idx="11">
                  <c:v>-5.6599999999999998E-2</c:v>
                </c:pt>
                <c:pt idx="12">
                  <c:v>-5.0200000000000002E-2</c:v>
                </c:pt>
                <c:pt idx="13">
                  <c:v>-0.33689999999999998</c:v>
                </c:pt>
                <c:pt idx="14">
                  <c:v>-0.1031</c:v>
                </c:pt>
              </c:numCache>
            </c:numRef>
          </c:xVal>
          <c:yVal>
            <c:numRef>
              <c:f>Sheet1!$C$2:$C$16</c:f>
              <c:numCache>
                <c:formatCode>General</c:formatCode>
                <c:ptCount val="15"/>
                <c:pt idx="0">
                  <c:v>0.22220000000000001</c:v>
                </c:pt>
                <c:pt idx="1">
                  <c:v>0.14940000000000001</c:v>
                </c:pt>
                <c:pt idx="2">
                  <c:v>0.1404</c:v>
                </c:pt>
                <c:pt idx="3">
                  <c:v>0.26090000000000002</c:v>
                </c:pt>
                <c:pt idx="4">
                  <c:v>0.2379</c:v>
                </c:pt>
                <c:pt idx="5">
                  <c:v>0.16700000000000001</c:v>
                </c:pt>
                <c:pt idx="6">
                  <c:v>0.13100000000000001</c:v>
                </c:pt>
                <c:pt idx="7">
                  <c:v>0.1163</c:v>
                </c:pt>
                <c:pt idx="8">
                  <c:v>0.1376</c:v>
                </c:pt>
                <c:pt idx="9">
                  <c:v>9.0499999999999997E-2</c:v>
                </c:pt>
                <c:pt idx="10">
                  <c:v>0.1275</c:v>
                </c:pt>
                <c:pt idx="11">
                  <c:v>0.2208</c:v>
                </c:pt>
                <c:pt idx="12">
                  <c:v>0.1246</c:v>
                </c:pt>
                <c:pt idx="13">
                  <c:v>0.23549999999999999</c:v>
                </c:pt>
                <c:pt idx="14">
                  <c:v>0.35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35C-3F49-AF09-A62637BA1C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7038208"/>
        <c:axId val="1642458336"/>
      </c:scatterChart>
      <c:valAx>
        <c:axId val="1607038208"/>
        <c:scaling>
          <c:orientation val="minMax"/>
          <c:max val="1.5"/>
          <c:min val="-1.5"/>
        </c:scaling>
        <c:delete val="0"/>
        <c:axPos val="t"/>
        <c:majorGridlines>
          <c:spPr>
            <a:ln w="9525" cap="flat" cmpd="sng" algn="ctr">
              <a:solidFill>
                <a:schemeClr val="bg2">
                  <a:lumMod val="9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642458336"/>
        <c:crossesAt val="-1"/>
        <c:crossBetween val="midCat"/>
      </c:valAx>
      <c:valAx>
        <c:axId val="1642458336"/>
        <c:scaling>
          <c:orientation val="maxMin"/>
        </c:scaling>
        <c:delete val="0"/>
        <c:axPos val="l"/>
        <c:majorGridlines>
          <c:spPr>
            <a:ln w="9525" cap="flat" cmpd="sng" algn="ctr">
              <a:solidFill>
                <a:schemeClr val="bg2">
                  <a:lumMod val="9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607038208"/>
        <c:crosses val="autoZero"/>
        <c:crossBetween val="midCat"/>
        <c:majorUnit val="0.1"/>
        <c:minorUnit val="0.1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 baseline="0"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53975">
                <a:solidFill>
                  <a:schemeClr val="tx1"/>
                </a:solidFill>
              </a:ln>
              <a:effectLst/>
            </c:spPr>
          </c:marker>
          <c:xVal>
            <c:numRef>
              <c:f>Sheet1!$B$2:$B$10</c:f>
              <c:numCache>
                <c:formatCode>General</c:formatCode>
                <c:ptCount val="9"/>
                <c:pt idx="0">
                  <c:v>-0.18629999999999999</c:v>
                </c:pt>
                <c:pt idx="1">
                  <c:v>0.1484</c:v>
                </c:pt>
                <c:pt idx="2">
                  <c:v>-0.26140000000000002</c:v>
                </c:pt>
                <c:pt idx="3">
                  <c:v>-0.32019999999999998</c:v>
                </c:pt>
                <c:pt idx="4">
                  <c:v>0.2167</c:v>
                </c:pt>
                <c:pt idx="5">
                  <c:v>-0.77649999999999997</c:v>
                </c:pt>
                <c:pt idx="6">
                  <c:v>0.1943</c:v>
                </c:pt>
                <c:pt idx="7">
                  <c:v>0.13100000000000001</c:v>
                </c:pt>
                <c:pt idx="8">
                  <c:v>6.2E-2</c:v>
                </c:pt>
              </c:numCache>
            </c:numRef>
          </c:xVal>
          <c:yVal>
            <c:numRef>
              <c:f>Sheet1!$C$2:$C$10</c:f>
              <c:numCache>
                <c:formatCode>General</c:formatCode>
                <c:ptCount val="9"/>
                <c:pt idx="0">
                  <c:v>0.10929999999999999</c:v>
                </c:pt>
                <c:pt idx="1">
                  <c:v>0.24329999999999999</c:v>
                </c:pt>
                <c:pt idx="2">
                  <c:v>0.3342</c:v>
                </c:pt>
                <c:pt idx="3">
                  <c:v>0.2555</c:v>
                </c:pt>
                <c:pt idx="4">
                  <c:v>0.35610000000000003</c:v>
                </c:pt>
                <c:pt idx="5">
                  <c:v>0.21809999999999999</c:v>
                </c:pt>
                <c:pt idx="6">
                  <c:v>0.23250000000000001</c:v>
                </c:pt>
                <c:pt idx="7">
                  <c:v>0.16189999999999999</c:v>
                </c:pt>
                <c:pt idx="8">
                  <c:v>9.6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A71-EE47-A147-BCCE0713B1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7038208"/>
        <c:axId val="1642458336"/>
      </c:scatterChart>
      <c:valAx>
        <c:axId val="1607038208"/>
        <c:scaling>
          <c:orientation val="minMax"/>
          <c:max val="1.5"/>
          <c:min val="-1.5"/>
        </c:scaling>
        <c:delete val="0"/>
        <c:axPos val="t"/>
        <c:majorGridlines>
          <c:spPr>
            <a:ln w="9525" cap="flat" cmpd="sng" algn="ctr">
              <a:solidFill>
                <a:schemeClr val="bg2">
                  <a:lumMod val="9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high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642458336"/>
        <c:crossesAt val="-1"/>
        <c:crossBetween val="midCat"/>
      </c:valAx>
      <c:valAx>
        <c:axId val="1642458336"/>
        <c:scaling>
          <c:orientation val="maxMin"/>
        </c:scaling>
        <c:delete val="0"/>
        <c:axPos val="l"/>
        <c:majorGridlines>
          <c:spPr>
            <a:ln w="9525" cap="flat" cmpd="sng" algn="ctr">
              <a:solidFill>
                <a:schemeClr val="bg2">
                  <a:lumMod val="90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6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ja-JP"/>
          </a:p>
        </c:txPr>
        <c:crossAx val="1607038208"/>
        <c:crosses val="autoZero"/>
        <c:crossBetween val="midCat"/>
        <c:majorUnit val="0.1"/>
        <c:minorUnit val="0.1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 baseline="0"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0A4567-0463-C941-8629-F09B9390DE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A98E7ED-EAF5-8A47-A478-744CE437B6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38E9CB-C525-5F49-956D-E757EF188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2F27563-9059-6A41-B945-F70BFF3EC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E14471-EC61-BE47-BAAD-2A4BD7ECCE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567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68BC56-1B32-C548-B431-BBA83E92F6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A768B44-D44F-F040-AB72-DADEAE5B4B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40B69A-51B6-454C-BAA4-F3F28DEFA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5B0694-7986-B140-BE41-9B92249EB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B675197-766A-124B-9757-4A7E21C7C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534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17DDF50-4849-0944-8EF0-DE96CE0D2F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934E432-E8A1-8E48-8E24-D10F83D80D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05AA909-CC78-5843-A03B-A0ED8A6DC2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5F8ABB3-C771-0940-BC4A-D60EABF431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203AC0-53E7-8948-8865-10F2C722B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9436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D967AB-F71A-8F4F-ADEC-C74572DE66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DB4C667-3226-6F40-A737-0CFCD7656D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3E4D59-FC4F-0441-BFAA-9DB4DF8CE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0A88F9E-33E1-E143-B8C3-A289968B78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A45C43-879D-5C4B-9763-CB078BCA3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2278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3AC0DD-99C4-2543-9599-FB94A0160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1B0AF48-8E0D-CB4A-B4F3-76FD7696FF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18051E-1EC4-B94A-AE95-719C19FAC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83EEFF1-8C54-BE40-9E72-49A6532302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0FEBAF5-A5A1-BF4E-BE77-26795BC68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842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BD055A-2461-414C-A824-A13D967DC2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ED65FB-4896-4849-A8D3-8DFDC6877C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0E7A92-601C-A948-8609-63565F3AD8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D737BF-200E-D74F-9AA4-1487AD0F1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4A6376-8EB8-4949-A268-C878C3391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52CDA68-E848-4C4B-821A-B30AFFC27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8852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11A879-A6EF-734F-8778-12B6EE803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A2058D3-2DB9-0148-BE65-5D27CE174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E941B06-EA23-FC46-8063-18519E06BD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1320404-CA11-DE4E-8AA4-05BF6B100B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8419538-089E-644C-AEE8-F89D3396A3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EA64215-88CC-D14D-B9A2-3682B274E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BA7C658-D828-FD45-A06E-FC3B3E2688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FF1D4B4-CB0C-9F4E-8B5A-245B66A4A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5879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AE730B-0FB2-A940-AA55-46A5FCA7B0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42997F4-67A7-C44D-BF60-7F3744900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D7B25BB-B872-004E-95DC-F674DD7B2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B8C951F-DE8E-0449-A289-A8284E3B4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208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592AEE4-7E7B-AC46-8BAD-195F54A57B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0499C34-0AB1-754D-A3D2-D56531508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696CD-D8EA-2346-B25B-398C81A0D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0963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CD6D89-7510-6849-966A-4F0A39DE56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1325216-34F9-B043-AF19-A46B7D81C7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1C1D39-665C-CA4D-BFD2-2966D5F90F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A39725-443A-EC47-9402-65952618A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29C01DC-DE1F-204A-B0C1-1C0D77926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255568-35AC-F945-9EF8-C6965C5679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491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6A0A4E-E1C4-FD48-AF27-AB2FA7BDA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6D7908F-6B4B-8D4A-B003-3913D1A9037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C43A259-EEDB-F649-88A4-989A6A2CEC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EB1A52-A2C7-584F-B0C5-88678B091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0AEACA2-FE19-FF45-B89B-41C15BCF5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4DF04F-E247-FA4D-B35C-8290E91AF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063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2F60E93-051A-8F4A-99D1-4650086CD4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F99DF2D-CEDB-2B48-987B-ADC64B983F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EC786D-3A8B-324E-9C32-3804351A38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D95D6-2736-0346-8ABE-D0EC1E60B5EE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21C155-F856-1C4E-B3D7-0BAF792C60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065CB5C-31EE-D04C-8E06-9A425E0649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256452-63ED-9840-9CB9-42513B04084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2331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8877BF32-E989-664C-A8D0-F9E885CEAF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7004713"/>
              </p:ext>
            </p:extLst>
          </p:nvPr>
        </p:nvGraphicFramePr>
        <p:xfrm>
          <a:off x="1863635" y="665792"/>
          <a:ext cx="4302034" cy="46887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B64A0D9-3C0E-BF44-811C-ECA37AFB0A71}"/>
              </a:ext>
            </a:extLst>
          </p:cNvPr>
          <p:cNvSpPr txBox="1"/>
          <p:nvPr/>
        </p:nvSpPr>
        <p:spPr>
          <a:xfrm rot="16200000">
            <a:off x="699947" y="2658916"/>
            <a:ext cx="173880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Standard Error</a:t>
            </a:r>
            <a:endParaRPr kumimoji="1" lang="ja-JP" altLang="en-US" sz="20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D9929F5-9A4C-9543-8EE2-197485E8867B}"/>
              </a:ext>
            </a:extLst>
          </p:cNvPr>
          <p:cNvSpPr txBox="1"/>
          <p:nvPr/>
        </p:nvSpPr>
        <p:spPr>
          <a:xfrm>
            <a:off x="3088356" y="5357713"/>
            <a:ext cx="2126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Log (Hazard Ratio)</a:t>
            </a:r>
            <a:endParaRPr kumimoji="1" lang="ja-JP" altLang="en-US" sz="20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71A498F6-D379-324A-96C7-C7A8B1359503}"/>
              </a:ext>
            </a:extLst>
          </p:cNvPr>
          <p:cNvCxnSpPr>
            <a:cxnSpLocks/>
          </p:cNvCxnSpPr>
          <p:nvPr/>
        </p:nvCxnSpPr>
        <p:spPr>
          <a:xfrm flipH="1">
            <a:off x="3335383" y="845243"/>
            <a:ext cx="864199" cy="4027459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F5F86CB8-3C6D-604A-993F-AC64A7A4628E}"/>
              </a:ext>
            </a:extLst>
          </p:cNvPr>
          <p:cNvCxnSpPr>
            <a:cxnSpLocks/>
          </p:cNvCxnSpPr>
          <p:nvPr/>
        </p:nvCxnSpPr>
        <p:spPr>
          <a:xfrm>
            <a:off x="4199581" y="846268"/>
            <a:ext cx="964602" cy="4026434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39EDF4E-05D0-5F42-80F7-FA3D295607BE}"/>
              </a:ext>
            </a:extLst>
          </p:cNvPr>
          <p:cNvSpPr txBox="1"/>
          <p:nvPr/>
        </p:nvSpPr>
        <p:spPr>
          <a:xfrm>
            <a:off x="1769407" y="301466"/>
            <a:ext cx="61633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b="1" dirty="0">
                <a:latin typeface="Calibri" panose="020F0502020204030204" pitchFamily="34" charset="0"/>
                <a:cs typeface="Calibri" panose="020F0502020204030204" pitchFamily="34" charset="0"/>
              </a:rPr>
              <a:t>a					b</a:t>
            </a:r>
            <a:endParaRPr lang="ja-JP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8877BF32-E989-664C-A8D0-F9E885CEAFA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7776195"/>
              </p:ext>
            </p:extLst>
          </p:nvPr>
        </p:nvGraphicFramePr>
        <p:xfrm>
          <a:off x="6523648" y="665791"/>
          <a:ext cx="4221610" cy="46887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2A8A42DF-C600-8742-8A62-E51FBFC925B4}"/>
              </a:ext>
            </a:extLst>
          </p:cNvPr>
          <p:cNvCxnSpPr>
            <a:cxnSpLocks/>
          </p:cNvCxnSpPr>
          <p:nvPr/>
        </p:nvCxnSpPr>
        <p:spPr>
          <a:xfrm flipH="1">
            <a:off x="7637417" y="845243"/>
            <a:ext cx="1112395" cy="4027459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FF0C5D4-09D8-844A-8DC8-EF33398DD068}"/>
              </a:ext>
            </a:extLst>
          </p:cNvPr>
          <p:cNvCxnSpPr>
            <a:cxnSpLocks/>
          </p:cNvCxnSpPr>
          <p:nvPr/>
        </p:nvCxnSpPr>
        <p:spPr>
          <a:xfrm>
            <a:off x="8749810" y="846268"/>
            <a:ext cx="1158221" cy="4026434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2A177A2-D2EA-8F4E-A1C6-8B556805A904}"/>
              </a:ext>
            </a:extLst>
          </p:cNvPr>
          <p:cNvSpPr txBox="1"/>
          <p:nvPr/>
        </p:nvSpPr>
        <p:spPr>
          <a:xfrm>
            <a:off x="7781295" y="5354509"/>
            <a:ext cx="21267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>
                <a:latin typeface="Calibri" panose="020F0502020204030204" pitchFamily="34" charset="0"/>
                <a:cs typeface="Calibri" panose="020F0502020204030204" pitchFamily="34" charset="0"/>
              </a:rPr>
              <a:t>Log (Hazard Ratio)</a:t>
            </a:r>
            <a:endParaRPr kumimoji="1" lang="ja-JP" altLang="en-US" sz="20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804A0F3-414E-9448-9707-4EE2C6EBE316}"/>
              </a:ext>
            </a:extLst>
          </p:cNvPr>
          <p:cNvSpPr txBox="1"/>
          <p:nvPr/>
        </p:nvSpPr>
        <p:spPr>
          <a:xfrm>
            <a:off x="1369296" y="6030652"/>
            <a:ext cx="10117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: Figure S2. Funnel plot of the studies included in the meta-analysis before (a) and after (b) 2012 </a:t>
            </a:r>
            <a:r>
              <a:rPr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to evaluat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the presence of publication bias.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4203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7</Words>
  <Application>Microsoft Macintosh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仲和宏</dc:creator>
  <cp:lastModifiedBy>田仲和宏</cp:lastModifiedBy>
  <cp:revision>12</cp:revision>
  <dcterms:created xsi:type="dcterms:W3CDTF">2018-10-07T14:55:40Z</dcterms:created>
  <dcterms:modified xsi:type="dcterms:W3CDTF">2018-12-11T04:57:59Z</dcterms:modified>
</cp:coreProperties>
</file>